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5D920-4CFE-49B9-9BF8-CEA71C134C3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44050-7A2E-445A-AB5D-6030181D3F9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2"/>
          <p:cNvGrpSpPr/>
          <p:nvPr/>
        </p:nvGrpSpPr>
        <p:grpSpPr>
          <a:xfrm>
            <a:off x="1752600" y="1295400"/>
            <a:ext cx="5562600" cy="5029200"/>
            <a:chOff x="2590800" y="2133600"/>
            <a:chExt cx="3810000" cy="3581400"/>
          </a:xfrm>
        </p:grpSpPr>
        <p:grpSp>
          <p:nvGrpSpPr>
            <p:cNvPr id="11" name="Group 10"/>
            <p:cNvGrpSpPr/>
            <p:nvPr/>
          </p:nvGrpSpPr>
          <p:grpSpPr>
            <a:xfrm>
              <a:off x="2895600" y="2209800"/>
              <a:ext cx="3124200" cy="3429000"/>
              <a:chOff x="2895600" y="2209800"/>
              <a:chExt cx="3124200" cy="3429000"/>
            </a:xfrm>
          </p:grpSpPr>
          <p:pic>
            <p:nvPicPr>
              <p:cNvPr id="3" name="Picture 2" descr="DQ two epitopes one on alpha one on beta.png"/>
              <p:cNvPicPr>
                <a:picLocks noChangeAspect="1"/>
              </p:cNvPicPr>
              <p:nvPr/>
            </p:nvPicPr>
            <p:blipFill>
              <a:blip r:embed="rId2" cstate="print"/>
              <a:srcRect l="31667" t="23663" r="34167" b="2265"/>
              <a:stretch>
                <a:fillRect/>
              </a:stretch>
            </p:blipFill>
            <p:spPr>
              <a:xfrm>
                <a:off x="2895600" y="2209800"/>
                <a:ext cx="3124200" cy="3429000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4953000" y="3810000"/>
                <a:ext cx="562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chemeClr val="bg1"/>
                    </a:solidFill>
                  </a:rPr>
                  <a:t>52H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886200" y="2514600"/>
                <a:ext cx="11664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chemeClr val="bg1"/>
                    </a:solidFill>
                  </a:rPr>
                  <a:t>Beta chain</a:t>
                </a:r>
                <a:endParaRPr lang="en-US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886200" y="4191000"/>
                <a:ext cx="128272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chemeClr val="bg1"/>
                    </a:solidFill>
                  </a:rPr>
                  <a:t>Alpha chain</a:t>
                </a:r>
                <a:endParaRPr lang="en-US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684012">
                <a:off x="4340517" y="3159640"/>
                <a:ext cx="9174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Peptide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657600" y="2819400"/>
                <a:ext cx="5164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chemeClr val="bg1"/>
                    </a:solidFill>
                  </a:rPr>
                  <a:t>52L</a:t>
                </a:r>
                <a:endParaRPr lang="en-US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2" name="Rectangle 11"/>
            <p:cNvSpPr/>
            <p:nvPr/>
          </p:nvSpPr>
          <p:spPr>
            <a:xfrm>
              <a:off x="2590800" y="2133600"/>
              <a:ext cx="3810000" cy="358140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430768"/>
            <a:ext cx="9144000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I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Serum from renal transplant patient with mismatch has two antibodies. One antibody targets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2017 (defined by 52H) on the DQA1*02:01 alpha chain and the other targets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2001 (defined by 52L) on the DQB1*02:02 beta chain. 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3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18:28Z</dcterms:created>
  <dcterms:modified xsi:type="dcterms:W3CDTF">2017-03-12T04:19:38Z</dcterms:modified>
</cp:coreProperties>
</file>